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56" r:id="rId5"/>
  </p:sldIdLst>
  <p:sldSz cx="6858000" cy="9144000" type="screen4x3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36" userDrawn="1">
          <p15:clr>
            <a:srgbClr val="A4A3A4"/>
          </p15:clr>
        </p15:guide>
        <p15:guide id="2" pos="288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68" d="100"/>
          <a:sy n="68" d="100"/>
        </p:scale>
        <p:origin x="1929" y="60"/>
      </p:cViewPr>
      <p:guideLst>
        <p:guide orient="horz" pos="2336"/>
        <p:guide pos="288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46651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45759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61154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87781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31719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12149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86507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98914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00876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13198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43977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22406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68632" y="7399975"/>
            <a:ext cx="5362222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6.  Images of Rad52-YFP foci.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Wild type and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hip1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Δ cells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expressing a Rad52-YFP fusion were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grown to mid log phase in EMM medium (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Prolif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 and then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uspended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in EMM-N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medium for 1 day to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induce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quiescence (-N). Restoration of a nitrogen source was achieved by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uspending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ells in rich (YES) medium for 4 hours at 30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C (+N 4hrs). Fluorescence microscopy was used to analyse cell nuclei for the presence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ad52-YFP foci which serve as markers of DNA double strand breaks.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Examples of Rad52-YFP foci are indicated. Note that Rad52 was previously known as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ad22 [37].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" name="Group 23"/>
          <p:cNvGrpSpPr/>
          <p:nvPr/>
        </p:nvGrpSpPr>
        <p:grpSpPr>
          <a:xfrm>
            <a:off x="501197" y="881891"/>
            <a:ext cx="4991490" cy="6036839"/>
            <a:chOff x="2177597" y="-37377"/>
            <a:chExt cx="4991490" cy="6036839"/>
          </a:xfrm>
        </p:grpSpPr>
        <p:sp>
          <p:nvSpPr>
            <p:cNvPr id="25" name="TextBox 24"/>
            <p:cNvSpPr txBox="1"/>
            <p:nvPr/>
          </p:nvSpPr>
          <p:spPr>
            <a:xfrm>
              <a:off x="3831041" y="-37376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GB" sz="16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6" name="Picture 25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347" t="4933" r="22017" b="26709"/>
            <a:stretch/>
          </p:blipFill>
          <p:spPr>
            <a:xfrm>
              <a:off x="5380241" y="247649"/>
              <a:ext cx="1788846" cy="1773292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751" t="25945" r="32088" b="5697"/>
            <a:stretch/>
          </p:blipFill>
          <p:spPr>
            <a:xfrm>
              <a:off x="5380240" y="4198667"/>
              <a:ext cx="1773291" cy="1773292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513" t="5758" r="32089" b="26623"/>
            <a:stretch/>
          </p:blipFill>
          <p:spPr>
            <a:xfrm>
              <a:off x="3331000" y="266810"/>
              <a:ext cx="1781068" cy="1754130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599" t="26684" r="6765" b="4658"/>
            <a:stretch/>
          </p:blipFill>
          <p:spPr>
            <a:xfrm>
              <a:off x="5380240" y="2215380"/>
              <a:ext cx="1788847" cy="1781069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459" t="28224" r="14143" b="3418"/>
            <a:stretch/>
          </p:blipFill>
          <p:spPr>
            <a:xfrm>
              <a:off x="3314701" y="2223158"/>
              <a:ext cx="1781069" cy="1773292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100" t="21725" r="36897" b="24570"/>
            <a:stretch/>
          </p:blipFill>
          <p:spPr>
            <a:xfrm>
              <a:off x="3331000" y="4198667"/>
              <a:ext cx="1819957" cy="1800795"/>
            </a:xfrm>
            <a:prstGeom prst="rect">
              <a:avLst/>
            </a:prstGeom>
          </p:spPr>
        </p:pic>
        <p:sp>
          <p:nvSpPr>
            <p:cNvPr id="32" name="TextBox 31"/>
            <p:cNvSpPr txBox="1"/>
            <p:nvPr/>
          </p:nvSpPr>
          <p:spPr>
            <a:xfrm>
              <a:off x="5982993" y="-37377"/>
              <a:ext cx="69602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p1∆</a:t>
              </a:r>
              <a:endParaRPr lang="en-GB" sz="16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Isosceles Triangle 32"/>
            <p:cNvSpPr/>
            <p:nvPr/>
          </p:nvSpPr>
          <p:spPr>
            <a:xfrm flipV="1">
              <a:off x="6288952" y="1153401"/>
              <a:ext cx="35966" cy="35966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4" name="Isosceles Triangle 33"/>
            <p:cNvSpPr/>
            <p:nvPr/>
          </p:nvSpPr>
          <p:spPr>
            <a:xfrm flipV="1">
              <a:off x="3977458" y="615178"/>
              <a:ext cx="35966" cy="35966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5" name="Isosceles Triangle 34"/>
            <p:cNvSpPr/>
            <p:nvPr/>
          </p:nvSpPr>
          <p:spPr>
            <a:xfrm flipV="1">
              <a:off x="6271747" y="2881501"/>
              <a:ext cx="35966" cy="35966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6" name="Isosceles Triangle 35"/>
            <p:cNvSpPr/>
            <p:nvPr/>
          </p:nvSpPr>
          <p:spPr>
            <a:xfrm flipV="1">
              <a:off x="6270411" y="4830236"/>
              <a:ext cx="35966" cy="35966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7" name="Isosceles Triangle 36"/>
            <p:cNvSpPr/>
            <p:nvPr/>
          </p:nvSpPr>
          <p:spPr>
            <a:xfrm flipV="1">
              <a:off x="4032159" y="5255182"/>
              <a:ext cx="35966" cy="35966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2519036" y="1112626"/>
              <a:ext cx="5934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rolif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2688954" y="2959434"/>
              <a:ext cx="4235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N 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2177597" y="4881716"/>
              <a:ext cx="81624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N 4hrs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278608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9D959B2D8FA5C4980890EF71530081A" ma:contentTypeVersion="14" ma:contentTypeDescription="Create a new document." ma:contentTypeScope="" ma:versionID="32fa3c235032fb6ef437c97435266abb">
  <xsd:schema xmlns:xsd="http://www.w3.org/2001/XMLSchema" xmlns:xs="http://www.w3.org/2001/XMLSchema" xmlns:p="http://schemas.microsoft.com/office/2006/metadata/properties" xmlns:ns3="1ff86b73-d2ed-45d1-9e31-5b4a0d263f49" xmlns:ns4="917767b3-d7cc-4621-8ad9-27e46fe3c43e" targetNamespace="http://schemas.microsoft.com/office/2006/metadata/properties" ma:root="true" ma:fieldsID="b46a7b92e6b6a21088fcbb1ddad5d57c" ns3:_="" ns4:_="">
    <xsd:import namespace="1ff86b73-d2ed-45d1-9e31-5b4a0d263f49"/>
    <xsd:import namespace="917767b3-d7cc-4621-8ad9-27e46fe3c43e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  <xsd:element ref="ns3:_activity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ff86b73-d2ed-45d1-9e31-5b4a0d263f4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1" nillable="true" ma:displayName="_activity" ma:hidden="true" ma:internalName="_activity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17767b3-d7cc-4621-8ad9-27e46fe3c43e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9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1ff86b73-d2ed-45d1-9e31-5b4a0d263f49" xsi:nil="true"/>
  </documentManagement>
</p:properties>
</file>

<file path=customXml/itemProps1.xml><?xml version="1.0" encoding="utf-8"?>
<ds:datastoreItem xmlns:ds="http://schemas.openxmlformats.org/officeDocument/2006/customXml" ds:itemID="{F520D1FE-73AA-4619-BD54-E2054754C22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ff86b73-d2ed-45d1-9e31-5b4a0d263f49"/>
    <ds:schemaRef ds:uri="917767b3-d7cc-4621-8ad9-27e46fe3c43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20612406-8E68-4E9C-B97F-9384BD404E70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DE464330-DA0F-4275-8676-1A734B70667A}">
  <ds:schemaRefs>
    <ds:schemaRef ds:uri="http://purl.org/dc/elements/1.1/"/>
    <ds:schemaRef ds:uri="http://schemas.microsoft.com/office/2006/metadata/properties"/>
    <ds:schemaRef ds:uri="1ff86b73-d2ed-45d1-9e31-5b4a0d263f49"/>
    <ds:schemaRef ds:uri="http://purl.org/dc/terms/"/>
    <ds:schemaRef ds:uri="http://schemas.openxmlformats.org/package/2006/metadata/core-properties"/>
    <ds:schemaRef ds:uri="917767b3-d7cc-4621-8ad9-27e46fe3c43e"/>
    <ds:schemaRef ds:uri="http://schemas.microsoft.com/office/2006/documentManagement/types"/>
    <ds:schemaRef ds:uri="http://schemas.microsoft.com/office/infopath/2007/PartnerControls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38</TotalTime>
  <Words>121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>Newcastl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mon Whitehall</dc:creator>
  <cp:lastModifiedBy>Simon_Admin</cp:lastModifiedBy>
  <cp:revision>45</cp:revision>
  <cp:lastPrinted>2018-05-04T14:46:18Z</cp:lastPrinted>
  <dcterms:created xsi:type="dcterms:W3CDTF">2017-02-01T13:08:09Z</dcterms:created>
  <dcterms:modified xsi:type="dcterms:W3CDTF">2023-06-28T14:33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9D959B2D8FA5C4980890EF71530081A</vt:lpwstr>
  </property>
</Properties>
</file>